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4" r:id="rId2"/>
    <p:sldId id="273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Stile chiaro 1 - Colore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3B4B98B0-60AC-42C2-AFA5-B58CD77FA1E5}" styleName="Stile chiaro 1 - Color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23"/>
    <p:restoredTop sz="95378"/>
  </p:normalViewPr>
  <p:slideViewPr>
    <p:cSldViewPr snapToGrid="0" snapToObjects="1">
      <p:cViewPr varScale="1">
        <p:scale>
          <a:sx n="107" d="100"/>
          <a:sy n="107" d="100"/>
        </p:scale>
        <p:origin x="174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8075C-DE28-E142-99EB-0E13757FC744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4510A7-013B-274A-9433-BB193CB95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8732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Review of the Literature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510A7-013B-274A-9433-BB193CB95B66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88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510A7-013B-274A-9433-BB193CB95B66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869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4646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73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397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4610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736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2028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862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8746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6013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2247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Trascinare l'immagine su un segnaposto o fare clic sull'icona per aggiunge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8998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6031D-4B16-6C46-98A4-486A48D9BE49}" type="datetimeFigureOut">
              <a:rPr lang="it-IT" smtClean="0"/>
              <a:t>30/01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EBA7C-4933-4B43-ADC6-057C4A8D361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518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A8609517-C07F-CC46-A66E-F52B20DEC5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1372635"/>
              </p:ext>
            </p:extLst>
          </p:nvPr>
        </p:nvGraphicFramePr>
        <p:xfrm>
          <a:off x="321548" y="376263"/>
          <a:ext cx="8500901" cy="6013312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929936">
                  <a:extLst>
                    <a:ext uri="{9D8B030D-6E8A-4147-A177-3AD203B41FA5}">
                      <a16:colId xmlns:a16="http://schemas.microsoft.com/office/drawing/2014/main" val="3388719846"/>
                    </a:ext>
                  </a:extLst>
                </a:gridCol>
                <a:gridCol w="9037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879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1012">
                  <a:extLst>
                    <a:ext uri="{9D8B030D-6E8A-4147-A177-3AD203B41FA5}">
                      <a16:colId xmlns:a16="http://schemas.microsoft.com/office/drawing/2014/main" val="2245001116"/>
                    </a:ext>
                  </a:extLst>
                </a:gridCol>
                <a:gridCol w="71721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17217">
                  <a:extLst>
                    <a:ext uri="{9D8B030D-6E8A-4147-A177-3AD203B41FA5}">
                      <a16:colId xmlns:a16="http://schemas.microsoft.com/office/drawing/2014/main" val="1129198880"/>
                    </a:ext>
                  </a:extLst>
                </a:gridCol>
                <a:gridCol w="4177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1668574696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28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1259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97088">
                  <a:extLst>
                    <a:ext uri="{9D8B030D-6E8A-4147-A177-3AD203B41FA5}">
                      <a16:colId xmlns:a16="http://schemas.microsoft.com/office/drawing/2014/main" val="4022395553"/>
                    </a:ext>
                  </a:extLst>
                </a:gridCol>
                <a:gridCol w="57061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4292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uthors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udy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° patient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ge(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ean</a:t>
                      </a:r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ime to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orbidity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ender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Byopsy</a:t>
                      </a:r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ribology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homs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b="1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urgery</a:t>
                      </a:r>
                      <a:endParaRPr lang="it-IT" sz="600" b="1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plications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b="1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utcomes</a:t>
                      </a:r>
                      <a:endParaRPr lang="it-IT" sz="600" b="1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037288762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ndit et al.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(200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9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trospectiv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3 (35 to  73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disloca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ner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ls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nmptoms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improved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2007450836"/>
                  </a:ext>
                </a:extLst>
              </a:tr>
              <a:tr h="390570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aur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1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3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C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plete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u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omsaft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20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883424274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rfitt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(2012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4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.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P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ood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unctional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2621579"/>
                  </a:ext>
                </a:extLst>
              </a:tr>
              <a:tr h="488212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lgarni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(2012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5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b="1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b="1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C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plete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u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omsaft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6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 no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currance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520398227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em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(2013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6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C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ood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unctio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691907568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Kawakita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(2013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7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.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C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ood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unc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ft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3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864806209"/>
                  </a:ext>
                </a:extLst>
              </a:tr>
              <a:tr h="404131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lmousa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3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0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rospecti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2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2F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8 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3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3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M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 patients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instabilit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emoral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er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lsy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lowly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ve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2335327899"/>
                  </a:ext>
                </a:extLst>
              </a:tr>
              <a:tr h="306489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Bisschop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3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1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4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1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mptomat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29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707960817"/>
                  </a:ext>
                </a:extLst>
              </a:tr>
              <a:tr h="306489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awabi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3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2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5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40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mptomat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15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 fontAlgn="b"/>
                      <a:endParaRPr lang="cs-CZ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178131695"/>
                  </a:ext>
                </a:extLst>
              </a:tr>
              <a:tr h="404131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Fu et al (2015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3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 and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view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0 (1)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7 (2)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0 (1) 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8(2)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nkylos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pondyliti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nkylos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pondyliti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>
                          <a:latin typeface="Palatino" pitchFamily="2" charset="77"/>
                          <a:ea typeface="Palatino" pitchFamily="2" charset="77"/>
                        </a:rPr>
                        <a:t>ye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>
                          <a:latin typeface="Palatino" pitchFamily="2" charset="77"/>
                          <a:ea typeface="Palatino" pitchFamily="2" charset="77"/>
                        </a:rPr>
                        <a:t>Swelling pain</a:t>
                      </a:r>
                    </a:p>
                    <a:p>
                      <a:pPr algn="ctr"/>
                      <a:r>
                        <a:rPr lang="it-IT" sz="600">
                          <a:latin typeface="Palatino" pitchFamily="2" charset="77"/>
                          <a:ea typeface="Palatino" pitchFamily="2" charset="77"/>
                        </a:rPr>
                        <a:t>Swelling pain 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Emipelvic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mputation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 stage (THA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2640534206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Zhai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5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4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trospecti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1.9(range 18-45)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emophilia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(7) B(1)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seutotumor excision</a:t>
                      </a:r>
                      <a:r>
                        <a:rPr lang="it-IT" sz="600" b="0" i="0" u="none" strike="noStrike" baseline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nd fixation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3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infectio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3619467117"/>
                  </a:ext>
                </a:extLst>
              </a:tr>
              <a:tr h="488212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bdel-Hamid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(2015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8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(</a:t>
                      </a:r>
                      <a:r>
                        <a:rPr lang="it-IT" sz="600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P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-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ignificant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improvement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of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well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ft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9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177645299"/>
                  </a:ext>
                </a:extLst>
              </a:tr>
              <a:tr h="404131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asegwa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 (2016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8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trospecti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6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5.7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9.7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nths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symptomsti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49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3 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6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mptomat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(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larg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seudotumo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)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46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-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167137974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ampbell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6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8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</a:t>
                      </a:r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e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syntomatic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783312493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ttino e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l. (2017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7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Abdominal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mass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wo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in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free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9993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Blau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7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2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.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Hip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8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elevated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erum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balt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  <a:p>
                      <a:pPr algn="ctr" fontAlgn="b"/>
                      <a:endParaRPr lang="is-I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o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currence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ecresed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level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balt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hromium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415348008"/>
                  </a:ext>
                </a:extLst>
              </a:tr>
            </a:tbl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FBE26C4B-5FF7-DAE1-3E49-86E3FAD8E41B}"/>
              </a:ext>
            </a:extLst>
          </p:cNvPr>
          <p:cNvSpPr txBox="1"/>
          <p:nvPr/>
        </p:nvSpPr>
        <p:spPr>
          <a:xfrm>
            <a:off x="266886" y="6419590"/>
            <a:ext cx="8280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>
                <a:latin typeface="Palatino" pitchFamily="2" charset="77"/>
                <a:ea typeface="Palatino" pitchFamily="2" charset="77"/>
              </a:rPr>
              <a:t>N.R.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not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reported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,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:mal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F:femal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oM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Metal on metal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oP:Metal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Polyetilen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o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oM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Metal; THA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total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Hip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Artroplasty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 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EF1EAA6B-57B1-3DAB-FFD1-B69DE58AB091}"/>
              </a:ext>
            </a:extLst>
          </p:cNvPr>
          <p:cNvSpPr txBox="1"/>
          <p:nvPr/>
        </p:nvSpPr>
        <p:spPr>
          <a:xfrm>
            <a:off x="321548" y="115416"/>
            <a:ext cx="85009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>
                <a:latin typeface="Palatino" pitchFamily="2" charset="77"/>
                <a:ea typeface="Palatino" pitchFamily="2" charset="77"/>
              </a:rPr>
              <a:t>Table</a:t>
            </a:r>
            <a:r>
              <a:rPr lang="it-IT" sz="900" dirty="0">
                <a:latin typeface="Palatino" pitchFamily="2" charset="77"/>
                <a:ea typeface="Palatino" pitchFamily="2" charset="77"/>
              </a:rPr>
              <a:t> S1. </a:t>
            </a:r>
            <a:r>
              <a:rPr lang="it-IT" sz="900" dirty="0" err="1">
                <a:latin typeface="Palatino" pitchFamily="2" charset="77"/>
                <a:ea typeface="Palatino" pitchFamily="2" charset="77"/>
              </a:rPr>
              <a:t>Published</a:t>
            </a:r>
            <a:r>
              <a:rPr lang="it-IT" sz="900" dirty="0">
                <a:latin typeface="Palatino" pitchFamily="2" charset="77"/>
                <a:ea typeface="Palatino" pitchFamily="2" charset="77"/>
              </a:rPr>
              <a:t> literature on management of </a:t>
            </a:r>
            <a:r>
              <a:rPr lang="it-IT" sz="900" dirty="0" err="1">
                <a:latin typeface="Palatino" pitchFamily="2" charset="77"/>
                <a:ea typeface="Palatino" pitchFamily="2" charset="77"/>
              </a:rPr>
              <a:t>pseudotumors</a:t>
            </a:r>
            <a:r>
              <a:rPr lang="it-IT" sz="900" dirty="0">
                <a:latin typeface="Palatino" pitchFamily="2" charset="77"/>
                <a:ea typeface="Palatino" pitchFamily="2" charset="77"/>
              </a:rPr>
              <a:t> of the hip.</a:t>
            </a:r>
          </a:p>
        </p:txBody>
      </p:sp>
    </p:spTree>
    <p:extLst>
      <p:ext uri="{BB962C8B-B14F-4D97-AF65-F5344CB8AC3E}">
        <p14:creationId xmlns:p14="http://schemas.microsoft.com/office/powerpoint/2010/main" val="60553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A8609517-C07F-CC46-A66E-F52B20DEC5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2324720"/>
              </p:ext>
            </p:extLst>
          </p:nvPr>
        </p:nvGraphicFramePr>
        <p:xfrm>
          <a:off x="355598" y="233096"/>
          <a:ext cx="8432804" cy="5835843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924986">
                  <a:extLst>
                    <a:ext uri="{9D8B030D-6E8A-4147-A177-3AD203B41FA5}">
                      <a16:colId xmlns:a16="http://schemas.microsoft.com/office/drawing/2014/main" val="3388719846"/>
                    </a:ext>
                  </a:extLst>
                </a:gridCol>
                <a:gridCol w="4853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36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8084">
                  <a:extLst>
                    <a:ext uri="{9D8B030D-6E8A-4147-A177-3AD203B41FA5}">
                      <a16:colId xmlns:a16="http://schemas.microsoft.com/office/drawing/2014/main" val="2245001116"/>
                    </a:ext>
                  </a:extLst>
                </a:gridCol>
                <a:gridCol w="8564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758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5298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7693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2465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2465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7088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792844">
                  <a:extLst>
                    <a:ext uri="{9D8B030D-6E8A-4147-A177-3AD203B41FA5}">
                      <a16:colId xmlns:a16="http://schemas.microsoft.com/office/drawing/2014/main" val="4022395553"/>
                    </a:ext>
                  </a:extLst>
                </a:gridCol>
                <a:gridCol w="567573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33847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uthors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udy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° patient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ge(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ean</a:t>
                      </a:r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ime to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orbidity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ende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ribology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Biopsy</a:t>
                      </a:r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homs</a:t>
                      </a:r>
                      <a:endParaRPr lang="it-IT" sz="6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b="1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urgery</a:t>
                      </a:r>
                      <a:endParaRPr lang="it-IT" sz="600" b="1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plications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b="1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utcomes</a:t>
                      </a:r>
                      <a:endParaRPr lang="it-IT" sz="600" b="1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037288762"/>
                  </a:ext>
                </a:extLst>
              </a:tr>
              <a:tr h="39888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Konan et al. (2017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5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pparativ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,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ultrasound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in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pseudotumo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7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6(34-38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24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47 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5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asyntomatic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8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ntomatic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8 patients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THA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ntomatic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seudotumo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86925246"/>
                  </a:ext>
                </a:extLst>
              </a:tr>
              <a:tr h="39888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utphe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6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trospecti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7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31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mptomat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39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.R</a:t>
                      </a: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398227609"/>
                  </a:ext>
                </a:extLst>
              </a:tr>
              <a:tr h="495263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meekes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1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pariso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of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thre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grading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system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with MRI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54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ymptomati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52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2512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udda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9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ood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ult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HHS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op 58 post op 87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ersso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1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7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rospecti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,7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(2-16)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steoarthriti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9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4 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ye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well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, mas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Excis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seudotumor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nd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the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odular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emoral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head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ocerami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aleb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W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. Grot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et al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(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018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resenta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and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literatur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review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presisio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external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iliac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vaii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age (revisio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THA)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omplete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utio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omsaft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4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year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997060142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ar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4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ase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erie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4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3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7Symptomatic 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17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asymptomatic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268446544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agoo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l. (2020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5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1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IV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Sever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hron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abdominal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syntomatic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psoas 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fluid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collection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communicat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with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prosthesi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inimal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in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2385728647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ossavaghi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. (2021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8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steoarthritis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Aseptic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loosen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HS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45 post 67</a:t>
                      </a:r>
                    </a:p>
                    <a:p>
                      <a:pPr algn="ctr" fontAlgn="b"/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Good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unctional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3117587559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Filer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l. (2021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0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Haemorragic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</a:rPr>
                        <a:t>pseudotumo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Hip (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Cer-Pol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) no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excision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seudotumor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gress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of the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seudotumor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ut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of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ymptoms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odriguetz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t al (2022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6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er-Ce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emoral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nerv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mpressio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o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no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i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aresthesia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and neuralgia 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ave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been</a:t>
                      </a:r>
                      <a:r>
                        <a:rPr lang="it-IT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solved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6046"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uang et al. (2022) </a:t>
                      </a:r>
                      <a:r>
                        <a:rPr lang="it-IT" sz="600" baseline="300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4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Case repor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N.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er-Cer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islocation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HS 90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symptomatic</a:t>
                      </a:r>
                      <a:endParaRPr lang="it-IT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98888"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sent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udy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trospectiv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udy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e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evision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of </a:t>
                      </a:r>
                      <a:r>
                        <a:rPr lang="it-IT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literature</a:t>
                      </a:r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2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69 (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ang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50-82)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9,86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(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range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1-20)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M, IPA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stoke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arthritis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besity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ysplasia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, ..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3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F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, </a:t>
                      </a: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8 M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1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7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MoM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2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C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1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CoP</a:t>
                      </a:r>
                      <a:endParaRPr lang="it-IT" sz="600" dirty="0"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ye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Swelling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, </a:t>
                      </a:r>
                      <a:r>
                        <a:rPr lang="it-IT" sz="600" dirty="0" err="1">
                          <a:latin typeface="Palatino" pitchFamily="2" charset="77"/>
                          <a:ea typeface="Palatino" pitchFamily="2" charset="77"/>
                        </a:rPr>
                        <a:t>pain</a:t>
                      </a:r>
                      <a:r>
                        <a:rPr lang="it-IT" sz="600" dirty="0"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0 </a:t>
                      </a: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e</a:t>
                      </a: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0 </a:t>
                      </a: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two</a:t>
                      </a: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stag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1 </a:t>
                      </a: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excision</a:t>
                      </a:r>
                      <a:r>
                        <a:rPr lang="it-IT" sz="600" b="1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="1" baseline="0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only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5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maior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( 2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eath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) 3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deep</a:t>
                      </a:r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</a:t>
                      </a:r>
                      <a:r>
                        <a:rPr lang="it-IT" sz="600" baseline="0" dirty="0" err="1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infection</a:t>
                      </a:r>
                      <a:endParaRPr lang="it-IT" sz="600" baseline="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  <a:p>
                      <a:pPr algn="ctr"/>
                      <a:r>
                        <a:rPr lang="it-IT" sz="600" baseline="0" dirty="0"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3 minor</a:t>
                      </a:r>
                    </a:p>
                    <a:p>
                      <a:pPr algn="ctr"/>
                      <a:endParaRPr lang="it-IT" sz="600" dirty="0"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HS </a:t>
                      </a:r>
                      <a:r>
                        <a:rPr lang="it-IT" sz="600" b="1" dirty="0" err="1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pre</a:t>
                      </a:r>
                      <a:r>
                        <a:rPr lang="it-IT" sz="600" b="1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 35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600" b="1" baseline="0" dirty="0">
                          <a:effectLst/>
                          <a:latin typeface="Palatino" pitchFamily="2" charset="77"/>
                          <a:ea typeface="Palatino" pitchFamily="2" charset="77"/>
                          <a:cs typeface="Calibri" charset="0"/>
                        </a:rPr>
                        <a:t>HHS post 75</a:t>
                      </a:r>
                      <a:endParaRPr lang="it-IT" sz="600" b="1" dirty="0">
                        <a:effectLst/>
                        <a:latin typeface="Palatino" pitchFamily="2" charset="77"/>
                        <a:ea typeface="Palatino" pitchFamily="2" charset="77"/>
                        <a:cs typeface="Calibri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555018751"/>
                  </a:ext>
                </a:extLst>
              </a:tr>
            </a:tbl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3A4431D7-0EEA-DF9B-2D83-01DE023836A8}"/>
              </a:ext>
            </a:extLst>
          </p:cNvPr>
          <p:cNvSpPr txBox="1"/>
          <p:nvPr/>
        </p:nvSpPr>
        <p:spPr>
          <a:xfrm>
            <a:off x="304799" y="6195319"/>
            <a:ext cx="85344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>
                <a:latin typeface="Palatino" pitchFamily="2" charset="77"/>
                <a:ea typeface="Palatino" pitchFamily="2" charset="77"/>
              </a:rPr>
              <a:t>N.R.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not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reported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,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:mal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F:femal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oM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Metal on metal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MoP:Metal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Polyetilene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o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oM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Ceramic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on Metal; THA: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total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 Hip </a:t>
            </a:r>
            <a:r>
              <a:rPr lang="it-IT" sz="700" dirty="0" err="1">
                <a:latin typeface="Palatino" pitchFamily="2" charset="77"/>
                <a:ea typeface="Palatino" pitchFamily="2" charset="77"/>
              </a:rPr>
              <a:t>Artroplasty</a:t>
            </a:r>
            <a:r>
              <a:rPr lang="it-IT" sz="700" dirty="0">
                <a:latin typeface="Palatino" pitchFamily="2" charset="77"/>
                <a:ea typeface="Palatino" pitchFamily="2" charset="77"/>
              </a:rPr>
              <a:t>, HHS: Harry Hip Scores, DM: </a:t>
            </a:r>
            <a:r>
              <a:rPr lang="it-IT" sz="700" b="0" dirty="0" err="1">
                <a:effectLst/>
                <a:latin typeface="Palatino" pitchFamily="2" charset="77"/>
                <a:ea typeface="Palatino" pitchFamily="2" charset="77"/>
              </a:rPr>
              <a:t>Diabetes</a:t>
            </a:r>
            <a:r>
              <a:rPr lang="it-IT" sz="700" b="0" dirty="0">
                <a:effectLst/>
                <a:latin typeface="Palatino" pitchFamily="2" charset="77"/>
                <a:ea typeface="Palatino" pitchFamily="2" charset="77"/>
              </a:rPr>
              <a:t> </a:t>
            </a:r>
            <a:r>
              <a:rPr lang="it-IT" sz="700" b="0" dirty="0" err="1">
                <a:effectLst/>
                <a:latin typeface="Palatino" pitchFamily="2" charset="77"/>
                <a:ea typeface="Palatino" pitchFamily="2" charset="77"/>
              </a:rPr>
              <a:t>Mellitus</a:t>
            </a:r>
            <a:r>
              <a:rPr lang="it-IT" sz="700" b="0" dirty="0">
                <a:effectLst/>
                <a:latin typeface="Palatino" pitchFamily="2" charset="77"/>
                <a:ea typeface="Palatino" pitchFamily="2" charset="77"/>
              </a:rPr>
              <a:t>; </a:t>
            </a:r>
            <a:r>
              <a:rPr lang="it-IT" sz="700" dirty="0">
                <a:latin typeface="Palatino" pitchFamily="2" charset="77"/>
                <a:ea typeface="Palatino" pitchFamily="2" charset="77"/>
                <a:cs typeface="Calibri" charset="0"/>
              </a:rPr>
              <a:t>IPA:</a:t>
            </a:r>
            <a:r>
              <a:rPr lang="it-IT" sz="700" b="0" dirty="0">
                <a:effectLst/>
                <a:latin typeface="Palatino" pitchFamily="2" charset="77"/>
                <a:ea typeface="Palatino" pitchFamily="2" charset="77"/>
              </a:rPr>
              <a:t> </a:t>
            </a:r>
            <a:r>
              <a:rPr lang="it-IT" sz="700" b="0" dirty="0" err="1">
                <a:effectLst/>
                <a:latin typeface="Palatino" pitchFamily="2" charset="77"/>
                <a:ea typeface="Palatino" pitchFamily="2" charset="77"/>
              </a:rPr>
              <a:t>Hypertension</a:t>
            </a:r>
            <a:endParaRPr lang="it-IT" sz="700" b="0" dirty="0">
              <a:effectLst/>
              <a:latin typeface="Palatino" pitchFamily="2" charset="77"/>
              <a:ea typeface="Palatino" pitchFamily="2" charset="77"/>
            </a:endParaRPr>
          </a:p>
          <a:p>
            <a:r>
              <a:rPr lang="it-IT" sz="700" b="0" dirty="0">
                <a:effectLst/>
                <a:latin typeface="Palatino" pitchFamily="2" charset="77"/>
                <a:ea typeface="Palatino" pitchFamily="2" charset="77"/>
              </a:rPr>
              <a:t>                                                                 </a:t>
            </a:r>
            <a:r>
              <a:rPr lang="it-IT" sz="700" b="0" baseline="0" dirty="0">
                <a:effectLst/>
                <a:latin typeface="Palatino" pitchFamily="2" charset="77"/>
                <a:ea typeface="Palatino" pitchFamily="2" charset="77"/>
              </a:rPr>
              <a:t> </a:t>
            </a:r>
            <a:r>
              <a:rPr lang="it-IT" sz="700" b="0" dirty="0">
                <a:effectLst/>
                <a:latin typeface="Palatino" pitchFamily="2" charset="77"/>
                <a:ea typeface="Palatino" pitchFamily="2" charset="77"/>
              </a:rPr>
              <a:t>                                                      </a:t>
            </a:r>
          </a:p>
          <a:p>
            <a:r>
              <a:rPr lang="it-IT" sz="700" dirty="0">
                <a:latin typeface="Palatino" pitchFamily="2" charset="77"/>
                <a:ea typeface="Palatino" pitchFamily="2" charset="77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7563972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956</TotalTime>
  <Words>1235</Words>
  <Application>Microsoft Macintosh PowerPoint</Application>
  <PresentationFormat>Presentazione su schermo (4:3)</PresentationFormat>
  <Paragraphs>417</Paragraphs>
  <Slides>2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Mariachiara Cerchiaro</dc:creator>
  <cp:lastModifiedBy>Cerchiaro</cp:lastModifiedBy>
  <cp:revision>92</cp:revision>
  <dcterms:created xsi:type="dcterms:W3CDTF">2023-06-01T14:42:47Z</dcterms:created>
  <dcterms:modified xsi:type="dcterms:W3CDTF">2024-01-30T08:56:25Z</dcterms:modified>
</cp:coreProperties>
</file>